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jpeg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358" r:id="rId5"/>
  </p:sldIdLst>
  <p:sldSz cx="6218238" cy="82296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CE5FC"/>
    <a:srgbClr val="DCB9FF"/>
    <a:srgbClr val="009999"/>
    <a:srgbClr val="C100C1"/>
    <a:srgbClr val="FF3399"/>
    <a:srgbClr val="E80E7B"/>
    <a:srgbClr val="E1F0EE"/>
    <a:srgbClr val="FCC8F0"/>
    <a:srgbClr val="F5C71D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17292A2E-F333-43FB-9621-5CBBE7FDCDCB}" styleName="Light Style 2 - Acc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6" autoAdjust="0"/>
    <p:restoredTop sz="96807" autoAdjust="0"/>
  </p:normalViewPr>
  <p:slideViewPr>
    <p:cSldViewPr snapToGrid="0">
      <p:cViewPr varScale="1">
        <p:scale>
          <a:sx n="98" d="100"/>
          <a:sy n="98" d="100"/>
        </p:scale>
        <p:origin x="10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9" y="1346836"/>
            <a:ext cx="5285502" cy="2865120"/>
          </a:xfrm>
        </p:spPr>
        <p:txBody>
          <a:bodyPr anchor="b"/>
          <a:lstStyle>
            <a:lvl1pPr algn="ctr"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280" y="4322446"/>
            <a:ext cx="4663679" cy="1986914"/>
          </a:xfrm>
        </p:spPr>
        <p:txBody>
          <a:bodyPr/>
          <a:lstStyle>
            <a:lvl1pPr marL="0" indent="0" algn="ctr">
              <a:buNone/>
              <a:defRPr sz="1632"/>
            </a:lvl1pPr>
            <a:lvl2pPr marL="310896" indent="0" algn="ctr">
              <a:buNone/>
              <a:defRPr sz="1360"/>
            </a:lvl2pPr>
            <a:lvl3pPr marL="621792" indent="0" algn="ctr">
              <a:buNone/>
              <a:defRPr sz="1224"/>
            </a:lvl3pPr>
            <a:lvl4pPr marL="932688" indent="0" algn="ctr">
              <a:buNone/>
              <a:defRPr sz="1088"/>
            </a:lvl4pPr>
            <a:lvl5pPr marL="1243584" indent="0" algn="ctr">
              <a:buNone/>
              <a:defRPr sz="1088"/>
            </a:lvl5pPr>
            <a:lvl6pPr marL="1554480" indent="0" algn="ctr">
              <a:buNone/>
              <a:defRPr sz="1088"/>
            </a:lvl6pPr>
            <a:lvl7pPr marL="1865376" indent="0" algn="ctr">
              <a:buNone/>
              <a:defRPr sz="1088"/>
            </a:lvl7pPr>
            <a:lvl8pPr marL="2176272" indent="0" algn="ctr">
              <a:buNone/>
              <a:defRPr sz="1088"/>
            </a:lvl8pPr>
            <a:lvl9pPr marL="2487168" indent="0" algn="ctr">
              <a:buNone/>
              <a:defRPr sz="108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596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44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49927" y="438150"/>
            <a:ext cx="1340808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504" y="438150"/>
            <a:ext cx="3944696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652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867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266" y="2051688"/>
            <a:ext cx="5363231" cy="3423284"/>
          </a:xfrm>
        </p:spPr>
        <p:txBody>
          <a:bodyPr anchor="b"/>
          <a:lstStyle>
            <a:lvl1pPr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266" y="5507358"/>
            <a:ext cx="5363231" cy="1800224"/>
          </a:xfrm>
        </p:spPr>
        <p:txBody>
          <a:bodyPr/>
          <a:lstStyle>
            <a:lvl1pPr marL="0" indent="0">
              <a:buNone/>
              <a:defRPr sz="1632">
                <a:solidFill>
                  <a:schemeClr val="tx1"/>
                </a:solidFill>
              </a:defRPr>
            </a:lvl1pPr>
            <a:lvl2pPr marL="31089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2pPr>
            <a:lvl3pPr marL="621792" indent="0">
              <a:buNone/>
              <a:defRPr sz="1224">
                <a:solidFill>
                  <a:schemeClr val="tx1">
                    <a:tint val="75000"/>
                  </a:schemeClr>
                </a:solidFill>
              </a:defRPr>
            </a:lvl3pPr>
            <a:lvl4pPr marL="93268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4pPr>
            <a:lvl5pPr marL="1243584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5pPr>
            <a:lvl6pPr marL="1554480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6pPr>
            <a:lvl7pPr marL="1865376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7pPr>
            <a:lvl8pPr marL="2176272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8pPr>
            <a:lvl9pPr marL="248716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634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505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7984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042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438152"/>
            <a:ext cx="5363231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315" y="2017396"/>
            <a:ext cx="2630605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315" y="3006090"/>
            <a:ext cx="263060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47985" y="2017396"/>
            <a:ext cx="2643561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47985" y="3006090"/>
            <a:ext cx="264356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002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21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658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3562" y="1184912"/>
            <a:ext cx="3147982" cy="5848350"/>
          </a:xfrm>
        </p:spPr>
        <p:txBody>
          <a:bodyPr/>
          <a:lstStyle>
            <a:lvl1pPr>
              <a:defRPr sz="2176"/>
            </a:lvl1pPr>
            <a:lvl2pPr>
              <a:defRPr sz="1904"/>
            </a:lvl2pPr>
            <a:lvl3pPr>
              <a:defRPr sz="1632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390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3562" y="1184912"/>
            <a:ext cx="3147982" cy="5848350"/>
          </a:xfrm>
        </p:spPr>
        <p:txBody>
          <a:bodyPr anchor="t"/>
          <a:lstStyle>
            <a:lvl1pPr marL="0" indent="0">
              <a:buNone/>
              <a:defRPr sz="2176"/>
            </a:lvl1pPr>
            <a:lvl2pPr marL="310896" indent="0">
              <a:buNone/>
              <a:defRPr sz="1904"/>
            </a:lvl2pPr>
            <a:lvl3pPr marL="621792" indent="0">
              <a:buNone/>
              <a:defRPr sz="1632"/>
            </a:lvl3pPr>
            <a:lvl4pPr marL="932688" indent="0">
              <a:buNone/>
              <a:defRPr sz="1360"/>
            </a:lvl4pPr>
            <a:lvl5pPr marL="1243584" indent="0">
              <a:buNone/>
              <a:defRPr sz="1360"/>
            </a:lvl5pPr>
            <a:lvl6pPr marL="1554480" indent="0">
              <a:buNone/>
              <a:defRPr sz="1360"/>
            </a:lvl6pPr>
            <a:lvl7pPr marL="1865376" indent="0">
              <a:buNone/>
              <a:defRPr sz="1360"/>
            </a:lvl7pPr>
            <a:lvl8pPr marL="2176272" indent="0">
              <a:buNone/>
              <a:defRPr sz="1360"/>
            </a:lvl8pPr>
            <a:lvl9pPr marL="2487168" indent="0">
              <a:buNone/>
              <a:defRPr sz="13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86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7504" y="438152"/>
            <a:ext cx="5363231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504" y="2190750"/>
            <a:ext cx="5363231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7503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9794" y="7627622"/>
            <a:ext cx="209865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1631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34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1792" rtl="0" eaLnBrk="1" latinLnBrk="0" hangingPunct="1">
        <a:lnSpc>
          <a:spcPct val="90000"/>
        </a:lnSpc>
        <a:spcBef>
          <a:spcPct val="0"/>
        </a:spcBef>
        <a:buNone/>
        <a:defRPr sz="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448" indent="-155448" algn="l" defTabSz="621792" rtl="0" eaLnBrk="1" latinLnBrk="0" hangingPunct="1">
        <a:lnSpc>
          <a:spcPct val="90000"/>
        </a:lnSpc>
        <a:spcBef>
          <a:spcPts val="680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632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360" kern="1200">
          <a:solidFill>
            <a:schemeClr val="tx1"/>
          </a:solidFill>
          <a:latin typeface="+mn-lt"/>
          <a:ea typeface="+mn-ea"/>
          <a:cs typeface="+mn-cs"/>
        </a:defRPr>
      </a:lvl3pPr>
      <a:lvl4pPr marL="108813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399032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709928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202082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33172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64261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1pPr>
      <a:lvl2pPr marL="31089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2pPr>
      <a:lvl3pPr marL="62179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3pPr>
      <a:lvl4pPr marL="93268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243584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55448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186537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17627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90CD7A9-45BE-242A-686A-A2D45F2C4D24}"/>
              </a:ext>
            </a:extLst>
          </p:cNvPr>
          <p:cNvSpPr txBox="1"/>
          <p:nvPr/>
        </p:nvSpPr>
        <p:spPr>
          <a:xfrm>
            <a:off x="434473" y="837802"/>
            <a:ext cx="4977968" cy="16509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5B</a:t>
            </a:r>
          </a:p>
          <a:p>
            <a:pPr>
              <a:lnSpc>
                <a:spcPct val="150000"/>
              </a:lnSpc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altered version of the gel image presented in Figure 5B are shown. Image was cropped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nd color-correc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PowerPoint to generate Figure 5B. </a:t>
            </a:r>
          </a:p>
        </p:txBody>
      </p:sp>
      <p:pic>
        <p:nvPicPr>
          <p:cNvPr id="19" name="Picture 18" descr="A close-up of a dna sequence&#10;&#10;Description automatically generated">
            <a:extLst>
              <a:ext uri="{FF2B5EF4-FFF2-40B4-BE49-F238E27FC236}">
                <a16:creationId xmlns:a16="http://schemas.microsoft.com/office/drawing/2014/main" id="{10E45828-42BF-D608-CD17-9C1587F43B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25" y="3138465"/>
            <a:ext cx="5540188" cy="4432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0696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875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2CA10241-3744-402C-BB55-0CCC07CA7F38}">
  <we:reference id="wa200006038" version="1.0.0.3" store="en-US" storeType="OMEX"/>
  <we:alternateReferences>
    <we:reference id="wa200006038" version="1.0.0.3" store="" storeType="OMEX"/>
  </we:alternateReferences>
  <we:properties/>
  <we:bindings/>
  <we:snapshot xmlns:r="http://schemas.openxmlformats.org/officeDocument/2006/relationships"/>
</we:webextension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6962610C67D4B49A88B6FAB491E3AE5" ma:contentTypeVersion="14" ma:contentTypeDescription="Create a new document." ma:contentTypeScope="" ma:versionID="bdab3a0ad6a9855bfbdcd6b489fe3c69">
  <xsd:schema xmlns:xsd="http://www.w3.org/2001/XMLSchema" xmlns:xs="http://www.w3.org/2001/XMLSchema" xmlns:p="http://schemas.microsoft.com/office/2006/metadata/properties" xmlns:ns3="18272914-71e0-42fc-9685-7c3d7493b947" xmlns:ns4="1ada6c1b-6627-4503-b0bd-5fd9b9908e29" targetNamespace="http://schemas.microsoft.com/office/2006/metadata/properties" ma:root="true" ma:fieldsID="63200ee40b5c47ed65451d97f7303378" ns3:_="" ns4:_="">
    <xsd:import namespace="18272914-71e0-42fc-9685-7c3d7493b947"/>
    <xsd:import namespace="1ada6c1b-6627-4503-b0bd-5fd9b9908e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ObjectDetectorVersions" minOccurs="0"/>
                <xsd:element ref="ns3:_activity" minOccurs="0"/>
                <xsd:element ref="ns3:MediaServiceSearchPropertie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8272914-71e0-42fc-9685-7c3d7493b94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6" nillable="true" ma:displayName="_activity" ma:hidden="true" ma:internalName="_activity">
      <xsd:simpleType>
        <xsd:restriction base="dms:Note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18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ada6c1b-6627-4503-b0bd-5fd9b9908e2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8272914-71e0-42fc-9685-7c3d7493b947" xsi:nil="true"/>
  </documentManagement>
</p:properties>
</file>

<file path=customXml/itemProps1.xml><?xml version="1.0" encoding="utf-8"?>
<ds:datastoreItem xmlns:ds="http://schemas.openxmlformats.org/officeDocument/2006/customXml" ds:itemID="{9D5C7AA1-25AA-4EAE-B43E-6AED5957082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7E71F50-D89D-49F9-A239-1B8EDA1963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8272914-71e0-42fc-9685-7c3d7493b947"/>
    <ds:schemaRef ds:uri="1ada6c1b-6627-4503-b0bd-5fd9b9908e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2A90B254-CE57-4786-8434-001DC6CED1BB}">
  <ds:schemaRefs>
    <ds:schemaRef ds:uri="http://purl.org/dc/dcmitype/"/>
    <ds:schemaRef ds:uri="http://schemas.microsoft.com/office/2006/documentManagement/types"/>
    <ds:schemaRef ds:uri="http://www.w3.org/XML/1998/namespace"/>
    <ds:schemaRef ds:uri="1ada6c1b-6627-4503-b0bd-5fd9b9908e29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18272914-71e0-42fc-9685-7c3d7493b947"/>
    <ds:schemaRef ds:uri="http://schemas.microsoft.com/office/2006/metadata/properties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537</TotalTime>
  <Words>30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bayet Elahi</dc:creator>
  <cp:lastModifiedBy>Rubayet Elahi</cp:lastModifiedBy>
  <cp:revision>1013</cp:revision>
  <cp:lastPrinted>2025-01-06T21:11:05Z</cp:lastPrinted>
  <dcterms:created xsi:type="dcterms:W3CDTF">2020-01-28T22:13:46Z</dcterms:created>
  <dcterms:modified xsi:type="dcterms:W3CDTF">2025-01-07T18:50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6962610C67D4B49A88B6FAB491E3AE5</vt:lpwstr>
  </property>
</Properties>
</file>